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9" r:id="rId2"/>
    <p:sldId id="258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198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B28F719-6893-4750-86BA-B219C7417315}" type="datetimeFigureOut">
              <a:rPr lang="en-US" smtClean="0"/>
              <a:t>6/9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A484BBE-259A-4FCA-BA32-D9FE90B608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16325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B9F81-B300-4465-8010-60BBA55ABC5F}" type="datetimeFigureOut">
              <a:rPr lang="en-US" smtClean="0"/>
              <a:t>6/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99A0F-DCFD-40FC-B07F-DA955C6722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86945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B9F81-B300-4465-8010-60BBA55ABC5F}" type="datetimeFigureOut">
              <a:rPr lang="en-US" smtClean="0"/>
              <a:t>6/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99A0F-DCFD-40FC-B07F-DA955C6722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80231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B9F81-B300-4465-8010-60BBA55ABC5F}" type="datetimeFigureOut">
              <a:rPr lang="en-US" smtClean="0"/>
              <a:t>6/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99A0F-DCFD-40FC-B07F-DA955C6722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79774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B9F81-B300-4465-8010-60BBA55ABC5F}" type="datetimeFigureOut">
              <a:rPr lang="en-US" smtClean="0"/>
              <a:t>6/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99A0F-DCFD-40FC-B07F-DA955C6722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20343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B9F81-B300-4465-8010-60BBA55ABC5F}" type="datetimeFigureOut">
              <a:rPr lang="en-US" smtClean="0"/>
              <a:t>6/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99A0F-DCFD-40FC-B07F-DA955C6722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38612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B9F81-B300-4465-8010-60BBA55ABC5F}" type="datetimeFigureOut">
              <a:rPr lang="en-US" smtClean="0"/>
              <a:t>6/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99A0F-DCFD-40FC-B07F-DA955C6722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5039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B9F81-B300-4465-8010-60BBA55ABC5F}" type="datetimeFigureOut">
              <a:rPr lang="en-US" smtClean="0"/>
              <a:t>6/9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99A0F-DCFD-40FC-B07F-DA955C6722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94651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B9F81-B300-4465-8010-60BBA55ABC5F}" type="datetimeFigureOut">
              <a:rPr lang="en-US" smtClean="0"/>
              <a:t>6/9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99A0F-DCFD-40FC-B07F-DA955C6722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64368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B9F81-B300-4465-8010-60BBA55ABC5F}" type="datetimeFigureOut">
              <a:rPr lang="en-US" smtClean="0"/>
              <a:t>6/9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99A0F-DCFD-40FC-B07F-DA955C6722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39511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B9F81-B300-4465-8010-60BBA55ABC5F}" type="datetimeFigureOut">
              <a:rPr lang="en-US" smtClean="0"/>
              <a:t>6/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99A0F-DCFD-40FC-B07F-DA955C6722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76980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B9F81-B300-4465-8010-60BBA55ABC5F}" type="datetimeFigureOut">
              <a:rPr lang="en-US" smtClean="0"/>
              <a:t>6/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99A0F-DCFD-40FC-B07F-DA955C6722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14505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4B9F81-B300-4465-8010-60BBA55ABC5F}" type="datetimeFigureOut">
              <a:rPr lang="en-US" smtClean="0"/>
              <a:t>6/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099A0F-DCFD-40FC-B07F-DA955C6722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69085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13" Type="http://schemas.openxmlformats.org/officeDocument/2006/relationships/image" Target="../media/image12.tif"/><Relationship Id="rId18" Type="http://schemas.openxmlformats.org/officeDocument/2006/relationships/image" Target="../media/image17.tif"/><Relationship Id="rId3" Type="http://schemas.openxmlformats.org/officeDocument/2006/relationships/image" Target="../media/image2.tif"/><Relationship Id="rId21" Type="http://schemas.openxmlformats.org/officeDocument/2006/relationships/image" Target="../media/image20.tif"/><Relationship Id="rId7" Type="http://schemas.openxmlformats.org/officeDocument/2006/relationships/image" Target="../media/image6.tif"/><Relationship Id="rId12" Type="http://schemas.openxmlformats.org/officeDocument/2006/relationships/image" Target="../media/image11.tif"/><Relationship Id="rId17" Type="http://schemas.openxmlformats.org/officeDocument/2006/relationships/image" Target="../media/image16.tif"/><Relationship Id="rId2" Type="http://schemas.openxmlformats.org/officeDocument/2006/relationships/image" Target="../media/image1.tif"/><Relationship Id="rId16" Type="http://schemas.openxmlformats.org/officeDocument/2006/relationships/image" Target="../media/image15.tif"/><Relationship Id="rId20" Type="http://schemas.openxmlformats.org/officeDocument/2006/relationships/image" Target="../media/image19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"/><Relationship Id="rId11" Type="http://schemas.openxmlformats.org/officeDocument/2006/relationships/image" Target="../media/image10.tif"/><Relationship Id="rId5" Type="http://schemas.openxmlformats.org/officeDocument/2006/relationships/image" Target="../media/image4.tif"/><Relationship Id="rId15" Type="http://schemas.openxmlformats.org/officeDocument/2006/relationships/image" Target="../media/image14.tif"/><Relationship Id="rId10" Type="http://schemas.openxmlformats.org/officeDocument/2006/relationships/image" Target="../media/image9.tif"/><Relationship Id="rId19" Type="http://schemas.openxmlformats.org/officeDocument/2006/relationships/image" Target="../media/image18.tif"/><Relationship Id="rId4" Type="http://schemas.openxmlformats.org/officeDocument/2006/relationships/image" Target="../media/image3.tif"/><Relationship Id="rId9" Type="http://schemas.openxmlformats.org/officeDocument/2006/relationships/image" Target="../media/image8.tif"/><Relationship Id="rId14" Type="http://schemas.openxmlformats.org/officeDocument/2006/relationships/image" Target="../media/image13.ti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tif"/><Relationship Id="rId3" Type="http://schemas.openxmlformats.org/officeDocument/2006/relationships/image" Target="../media/image22.tif"/><Relationship Id="rId7" Type="http://schemas.openxmlformats.org/officeDocument/2006/relationships/image" Target="../media/image26.tif"/><Relationship Id="rId2" Type="http://schemas.openxmlformats.org/officeDocument/2006/relationships/image" Target="../media/image21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5.tif"/><Relationship Id="rId11" Type="http://schemas.openxmlformats.org/officeDocument/2006/relationships/image" Target="../media/image30.tif"/><Relationship Id="rId5" Type="http://schemas.openxmlformats.org/officeDocument/2006/relationships/image" Target="../media/image24.tif"/><Relationship Id="rId10" Type="http://schemas.openxmlformats.org/officeDocument/2006/relationships/image" Target="../media/image29.tif"/><Relationship Id="rId4" Type="http://schemas.openxmlformats.org/officeDocument/2006/relationships/image" Target="../media/image23.tif"/><Relationship Id="rId9" Type="http://schemas.openxmlformats.org/officeDocument/2006/relationships/image" Target="../media/image28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/>
          <p:cNvSpPr txBox="1"/>
          <p:nvPr/>
        </p:nvSpPr>
        <p:spPr>
          <a:xfrm>
            <a:off x="1161984" y="186951"/>
            <a:ext cx="66345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Merged                Nucleus (DAPI)        CK8,18,19 (FITC)          </a:t>
            </a:r>
            <a:r>
              <a:rPr lang="en-US" sz="1400" dirty="0" err="1" smtClean="0"/>
              <a:t>EpCAM</a:t>
            </a:r>
            <a:r>
              <a:rPr lang="en-US" sz="1400" dirty="0" smtClean="0"/>
              <a:t> (PE)             CD45 (CY5)</a:t>
            </a:r>
            <a:endParaRPr lang="en-US" sz="1400" dirty="0"/>
          </a:p>
        </p:txBody>
      </p:sp>
      <p:sp>
        <p:nvSpPr>
          <p:cNvPr id="7" name="TextBox 6"/>
          <p:cNvSpPr txBox="1"/>
          <p:nvPr/>
        </p:nvSpPr>
        <p:spPr>
          <a:xfrm>
            <a:off x="8061605" y="2362200"/>
            <a:ext cx="5517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LN2</a:t>
            </a:r>
            <a:endParaRPr lang="en-US" b="1" dirty="0"/>
          </a:p>
        </p:txBody>
      </p:sp>
      <p:sp>
        <p:nvSpPr>
          <p:cNvPr id="8" name="TextBox 7"/>
          <p:cNvSpPr txBox="1"/>
          <p:nvPr/>
        </p:nvSpPr>
        <p:spPr>
          <a:xfrm>
            <a:off x="180556" y="478666"/>
            <a:ext cx="54854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dirty="0" smtClean="0"/>
              <a:t>(A) 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7992676" y="995862"/>
            <a:ext cx="6896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-80°C</a:t>
            </a:r>
            <a:endParaRPr lang="en-US" b="1" dirty="0"/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1456" y="492456"/>
            <a:ext cx="1371600" cy="1371600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04984" y="492456"/>
            <a:ext cx="1371600" cy="137160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92913" y="492456"/>
            <a:ext cx="1371600" cy="1371600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24384" y="492456"/>
            <a:ext cx="1371600" cy="1371600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60963" y="494728"/>
            <a:ext cx="1371600" cy="1371600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9807" y="1950787"/>
            <a:ext cx="1371600" cy="1371600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56663" y="1950787"/>
            <a:ext cx="1371600" cy="1371600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92913" y="1961673"/>
            <a:ext cx="1371600" cy="1371600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24384" y="1961673"/>
            <a:ext cx="1371600" cy="1371600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60963" y="1961673"/>
            <a:ext cx="1371600" cy="1371600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8061605" y="5744005"/>
            <a:ext cx="5517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LN2</a:t>
            </a:r>
            <a:endParaRPr lang="en-US" b="1" dirty="0"/>
          </a:p>
        </p:txBody>
      </p:sp>
      <p:pic>
        <p:nvPicPr>
          <p:cNvPr id="22" name="Picture 21"/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4298" y="3778742"/>
            <a:ext cx="1371600" cy="1371600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51154" y="3778742"/>
            <a:ext cx="1371600" cy="1371600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7404" y="3778742"/>
            <a:ext cx="1371600" cy="1371600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21596" y="3778742"/>
            <a:ext cx="1371600" cy="1371600"/>
          </a:xfrm>
          <a:prstGeom prst="rect">
            <a:avLst/>
          </a:prstGeom>
        </p:spPr>
      </p:pic>
      <p:pic>
        <p:nvPicPr>
          <p:cNvPr id="26" name="Picture 25"/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55454" y="3778742"/>
            <a:ext cx="1371600" cy="1371600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9807" y="5226542"/>
            <a:ext cx="1366091" cy="1371600"/>
          </a:xfrm>
          <a:prstGeom prst="rect">
            <a:avLst/>
          </a:prstGeom>
        </p:spPr>
      </p:pic>
      <p:pic>
        <p:nvPicPr>
          <p:cNvPr id="28" name="Picture 27"/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56663" y="5242871"/>
            <a:ext cx="1366091" cy="1371600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98422" y="5226542"/>
            <a:ext cx="1366091" cy="1371600"/>
          </a:xfrm>
          <a:prstGeom prst="rect">
            <a:avLst/>
          </a:prstGeom>
        </p:spPr>
      </p:pic>
      <p:pic>
        <p:nvPicPr>
          <p:cNvPr id="30" name="Picture 29"/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27105" y="5226542"/>
            <a:ext cx="1366091" cy="1371600"/>
          </a:xfrm>
          <a:prstGeom prst="rect">
            <a:avLst/>
          </a:prstGeom>
        </p:spPr>
      </p:pic>
      <p:pic>
        <p:nvPicPr>
          <p:cNvPr id="31" name="Picture 30"/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66472" y="5226542"/>
            <a:ext cx="1366091" cy="1371600"/>
          </a:xfrm>
          <a:prstGeom prst="rect">
            <a:avLst/>
          </a:prstGeom>
        </p:spPr>
      </p:pic>
      <p:sp>
        <p:nvSpPr>
          <p:cNvPr id="32" name="TextBox 31"/>
          <p:cNvSpPr txBox="1"/>
          <p:nvPr/>
        </p:nvSpPr>
        <p:spPr>
          <a:xfrm>
            <a:off x="7974477" y="4273502"/>
            <a:ext cx="6896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-80°C</a:t>
            </a:r>
            <a:endParaRPr lang="en-US" b="1" dirty="0"/>
          </a:p>
        </p:txBody>
      </p:sp>
      <p:sp>
        <p:nvSpPr>
          <p:cNvPr id="33" name="TextBox 32"/>
          <p:cNvSpPr txBox="1"/>
          <p:nvPr/>
        </p:nvSpPr>
        <p:spPr>
          <a:xfrm>
            <a:off x="1161984" y="3480148"/>
            <a:ext cx="67467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Merged                 Nucleus (DAPI)      CK8,18,19 (FITC)      Vimentin (EF615)        CD45 (CY5)</a:t>
            </a:r>
            <a:endParaRPr lang="en-US" sz="1400" dirty="0"/>
          </a:p>
        </p:txBody>
      </p:sp>
      <p:sp>
        <p:nvSpPr>
          <p:cNvPr id="34" name="TextBox 33"/>
          <p:cNvSpPr txBox="1"/>
          <p:nvPr/>
        </p:nvSpPr>
        <p:spPr>
          <a:xfrm>
            <a:off x="180556" y="3778742"/>
            <a:ext cx="53893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dirty="0" smtClean="0"/>
              <a:t>(B) 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1674462" y="573991"/>
            <a:ext cx="5469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</a:rPr>
              <a:t>MCF7</a:t>
            </a:r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1668952" y="2071117"/>
            <a:ext cx="5469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</a:rPr>
              <a:t>MCF7</a:t>
            </a:r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1609618" y="3791008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</a:rPr>
              <a:t>786-O</a:t>
            </a:r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1646511" y="5242871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</a:rPr>
              <a:t>786-O</a:t>
            </a:r>
            <a:endParaRPr lang="en-US" sz="120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208880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/>
          <p:cNvSpPr txBox="1"/>
          <p:nvPr/>
        </p:nvSpPr>
        <p:spPr>
          <a:xfrm>
            <a:off x="1198563" y="313070"/>
            <a:ext cx="66345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Merged                Nucleus (DAPI)        CK8,18,19 (FITC)         </a:t>
            </a:r>
            <a:r>
              <a:rPr lang="en-US" sz="1400" dirty="0" err="1" smtClean="0"/>
              <a:t>EpCAM</a:t>
            </a:r>
            <a:r>
              <a:rPr lang="en-US" sz="1400" dirty="0" smtClean="0"/>
              <a:t> (PE)              CD45 (CY5)</a:t>
            </a:r>
            <a:endParaRPr lang="en-US" sz="1400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1131" y="2052507"/>
            <a:ext cx="1371600" cy="13716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49889" y="2049786"/>
            <a:ext cx="1371600" cy="13716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59427" y="2052507"/>
            <a:ext cx="1371600" cy="13716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0963" y="2049786"/>
            <a:ext cx="1371600" cy="13716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54334" y="2049786"/>
            <a:ext cx="1371600" cy="137160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8054976" y="2553641"/>
            <a:ext cx="5517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LN2</a:t>
            </a:r>
            <a:endParaRPr lang="en-US" b="1" dirty="0"/>
          </a:p>
        </p:txBody>
      </p:sp>
      <p:sp>
        <p:nvSpPr>
          <p:cNvPr id="8" name="TextBox 7"/>
          <p:cNvSpPr txBox="1"/>
          <p:nvPr/>
        </p:nvSpPr>
        <p:spPr>
          <a:xfrm>
            <a:off x="322395" y="613106"/>
            <a:ext cx="47801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/>
              <a:t>(C)</a:t>
            </a:r>
            <a:endParaRPr lang="en-US" sz="2000" dirty="0"/>
          </a:p>
        </p:txBody>
      </p:sp>
      <p:pic>
        <p:nvPicPr>
          <p:cNvPr id="29" name="Picture 28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1131" y="644211"/>
            <a:ext cx="1371600" cy="1371600"/>
          </a:xfrm>
          <a:prstGeom prst="rect">
            <a:avLst/>
          </a:prstGeom>
        </p:spPr>
      </p:pic>
      <p:pic>
        <p:nvPicPr>
          <p:cNvPr id="30" name="Picture 29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47224" y="658948"/>
            <a:ext cx="1371600" cy="1371600"/>
          </a:xfrm>
          <a:prstGeom prst="rect">
            <a:avLst/>
          </a:prstGeom>
        </p:spPr>
      </p:pic>
      <p:pic>
        <p:nvPicPr>
          <p:cNvPr id="31" name="Picture 30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62149" y="656349"/>
            <a:ext cx="1371600" cy="1371600"/>
          </a:xfrm>
          <a:prstGeom prst="rect">
            <a:avLst/>
          </a:prstGeom>
        </p:spPr>
      </p:pic>
      <p:pic>
        <p:nvPicPr>
          <p:cNvPr id="32" name="Picture 31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0963" y="658948"/>
            <a:ext cx="1371600" cy="1371600"/>
          </a:xfrm>
          <a:prstGeom prst="rect">
            <a:avLst/>
          </a:prstGeom>
        </p:spPr>
      </p:pic>
      <p:pic>
        <p:nvPicPr>
          <p:cNvPr id="33" name="Picture 32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51613" y="658948"/>
            <a:ext cx="1371600" cy="1371600"/>
          </a:xfrm>
          <a:prstGeom prst="rect">
            <a:avLst/>
          </a:prstGeom>
        </p:spPr>
      </p:pic>
      <p:sp>
        <p:nvSpPr>
          <p:cNvPr id="35" name="TextBox 34"/>
          <p:cNvSpPr txBox="1"/>
          <p:nvPr/>
        </p:nvSpPr>
        <p:spPr>
          <a:xfrm>
            <a:off x="7986047" y="1145345"/>
            <a:ext cx="6896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-80°C</a:t>
            </a:r>
            <a:endParaRPr lang="en-US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1774910" y="736217"/>
            <a:ext cx="5613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</a:rPr>
              <a:t>PBMC</a:t>
            </a:r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785852" y="2161620"/>
            <a:ext cx="5613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</a:rPr>
              <a:t>PBMC</a:t>
            </a:r>
            <a:endParaRPr lang="en-US" sz="120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994567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96</TotalTime>
  <Words>75</Words>
  <Application>Microsoft Office PowerPoint</Application>
  <PresentationFormat>On-screen Show (4:3)</PresentationFormat>
  <Paragraphs>18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ixuan Zhu</dc:creator>
  <cp:lastModifiedBy>Thai H Ho</cp:lastModifiedBy>
  <cp:revision>166</cp:revision>
  <dcterms:created xsi:type="dcterms:W3CDTF">2016-02-26T15:38:12Z</dcterms:created>
  <dcterms:modified xsi:type="dcterms:W3CDTF">2016-06-09T17:46:46Z</dcterms:modified>
</cp:coreProperties>
</file>